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364FDE-30C5-4ED8-BE48-C82E4F80801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CBB73C-1794-4858-BC4C-2020C93ECF4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72FD35-5D31-4FF1-B825-C6A5D9288B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BFD27-E916-40FE-A6A8-3805486A61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D42DC-669D-42ED-B16A-98ACEF1E24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D36AB-E8C5-43EC-BBF7-83D8DF62EA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59F0DD-AE37-4E47-9689-D93BD1859E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D76056-0F77-4E91-B2DC-570580BF7B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D4530-E186-466A-9B11-7DA7EA3162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D89FCA-F334-4CE2-8C36-878B8998B0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249363-5100-448E-9FD6-ACC9C41DE0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8E9EB-8A10-43AF-9806-1FD54812CE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52C0A-B58D-4679-8C4C-C3B548F318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988399-1129-49BB-9E6A-1D4B396F39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228EFD-786F-4507-8D41-C7C08D4B1FC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ontent Placeholder 3" descr=""/>
          <p:cNvPicPr/>
          <p:nvPr/>
        </p:nvPicPr>
        <p:blipFill>
          <a:blip r:embed="rId1"/>
          <a:stretch/>
        </p:blipFill>
        <p:spPr>
          <a:xfrm>
            <a:off x="450720" y="1060560"/>
            <a:ext cx="8242560" cy="4535280"/>
          </a:xfrm>
          <a:prstGeom prst="rect">
            <a:avLst/>
          </a:prstGeom>
          <a:ln w="0">
            <a:noFill/>
          </a:ln>
        </p:spPr>
      </p:pic>
      <p:sp>
        <p:nvSpPr>
          <p:cNvPr id="49" name="TextBox 4"/>
          <p:cNvSpPr/>
          <p:nvPr/>
        </p:nvSpPr>
        <p:spPr>
          <a:xfrm>
            <a:off x="3203280" y="40384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5"/>
          <p:cNvSpPr/>
          <p:nvPr/>
        </p:nvSpPr>
        <p:spPr>
          <a:xfrm>
            <a:off x="3511080" y="28954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6"/>
          <p:cNvSpPr/>
          <p:nvPr/>
        </p:nvSpPr>
        <p:spPr>
          <a:xfrm>
            <a:off x="4346280" y="45831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7"/>
          <p:cNvSpPr/>
          <p:nvPr/>
        </p:nvSpPr>
        <p:spPr>
          <a:xfrm>
            <a:off x="4195440" y="3352680"/>
            <a:ext cx="8575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  <a:ea typeface="Arial"/>
              </a:rPr>
              <a:t>273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8"/>
          <p:cNvSpPr/>
          <p:nvPr/>
        </p:nvSpPr>
        <p:spPr>
          <a:xfrm>
            <a:off x="4501800" y="20574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9"/>
          <p:cNvSpPr/>
          <p:nvPr/>
        </p:nvSpPr>
        <p:spPr>
          <a:xfrm>
            <a:off x="5416200" y="290664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0"/>
          <p:cNvSpPr/>
          <p:nvPr/>
        </p:nvSpPr>
        <p:spPr>
          <a:xfrm>
            <a:off x="5721120" y="41148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Rectangle 11"/>
          <p:cNvGrpSpPr/>
          <p:nvPr/>
        </p:nvGrpSpPr>
        <p:grpSpPr>
          <a:xfrm>
            <a:off x="1620720" y="5834160"/>
            <a:ext cx="1787760" cy="792000"/>
            <a:chOff x="1620720" y="5834160"/>
            <a:chExt cx="1787760" cy="792000"/>
          </a:xfrm>
        </p:grpSpPr>
        <p:pic>
          <p:nvPicPr>
            <p:cNvPr id="57" name="Rectangle 11" descr=""/>
            <p:cNvPicPr/>
            <p:nvPr/>
          </p:nvPicPr>
          <p:blipFill>
            <a:blip r:embed="rId2"/>
            <a:stretch/>
          </p:blipFill>
          <p:spPr>
            <a:xfrm>
              <a:off x="1620720" y="5834160"/>
              <a:ext cx="1787760" cy="79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"/>
            <p:cNvSpPr/>
            <p:nvPr/>
          </p:nvSpPr>
          <p:spPr>
            <a:xfrm>
              <a:off x="1679400" y="5867280"/>
              <a:ext cx="1673280" cy="68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 mg tissu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9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Rectangle 12"/>
          <p:cNvGrpSpPr/>
          <p:nvPr/>
        </p:nvGrpSpPr>
        <p:grpSpPr>
          <a:xfrm>
            <a:off x="6035760" y="5834160"/>
            <a:ext cx="1792080" cy="792000"/>
            <a:chOff x="6035760" y="5834160"/>
            <a:chExt cx="1792080" cy="792000"/>
          </a:xfrm>
        </p:grpSpPr>
        <p:pic>
          <p:nvPicPr>
            <p:cNvPr id="60" name="Rectangle 12" descr=""/>
            <p:cNvPicPr/>
            <p:nvPr/>
          </p:nvPicPr>
          <p:blipFill>
            <a:blip r:embed="rId3"/>
            <a:stretch/>
          </p:blipFill>
          <p:spPr>
            <a:xfrm>
              <a:off x="6035760" y="5834160"/>
              <a:ext cx="1792080" cy="79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"/>
            <p:cNvSpPr/>
            <p:nvPr/>
          </p:nvSpPr>
          <p:spPr>
            <a:xfrm>
              <a:off x="6095880" y="5867280"/>
              <a:ext cx="1676520" cy="68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round biops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8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" name="Rectangle 13"/>
          <p:cNvGrpSpPr/>
          <p:nvPr/>
        </p:nvGrpSpPr>
        <p:grpSpPr>
          <a:xfrm>
            <a:off x="3828960" y="5834160"/>
            <a:ext cx="1790640" cy="792000"/>
            <a:chOff x="3828960" y="5834160"/>
            <a:chExt cx="1790640" cy="792000"/>
          </a:xfrm>
        </p:grpSpPr>
        <p:pic>
          <p:nvPicPr>
            <p:cNvPr id="63" name="Rectangle 13" descr=""/>
            <p:cNvPicPr/>
            <p:nvPr/>
          </p:nvPicPr>
          <p:blipFill>
            <a:blip r:embed="rId4"/>
            <a:stretch/>
          </p:blipFill>
          <p:spPr>
            <a:xfrm>
              <a:off x="3828960" y="5834160"/>
              <a:ext cx="1790640" cy="79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"/>
            <p:cNvSpPr/>
            <p:nvPr/>
          </p:nvSpPr>
          <p:spPr>
            <a:xfrm>
              <a:off x="3889440" y="5867280"/>
              <a:ext cx="1673280" cy="68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tact biops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8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TextBox 18"/>
          <p:cNvSpPr/>
          <p:nvPr/>
        </p:nvSpPr>
        <p:spPr>
          <a:xfrm>
            <a:off x="4038480" y="1066680"/>
            <a:ext cx="1143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ntact biops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9"/>
          <p:cNvSpPr/>
          <p:nvPr/>
        </p:nvSpPr>
        <p:spPr>
          <a:xfrm>
            <a:off x="6400800" y="4114800"/>
            <a:ext cx="12952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round biops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0"/>
          <p:cNvSpPr/>
          <p:nvPr/>
        </p:nvSpPr>
        <p:spPr>
          <a:xfrm>
            <a:off x="1828800" y="4114800"/>
            <a:ext cx="990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30 mg tissu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21"/>
          <p:cNvSpPr/>
          <p:nvPr/>
        </p:nvSpPr>
        <p:spPr>
          <a:xfrm>
            <a:off x="152280" y="152280"/>
            <a:ext cx="281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9T20:06:05Z</dcterms:created>
  <dc:creator>mbrown</dc:creator>
  <dc:description/>
  <dc:language>en-US</dc:language>
  <cp:lastModifiedBy>mbrown</cp:lastModifiedBy>
  <dcterms:modified xsi:type="dcterms:W3CDTF">2012-03-27T15:07:46Z</dcterms:modified>
  <cp:revision>3</cp:revision>
  <dc:subject/>
  <dc:title>Slide 1</dc:title>
</cp:coreProperties>
</file>